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11981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 showGuides="1">
      <p:cViewPr>
        <p:scale>
          <a:sx n="94" d="100"/>
          <a:sy n="94" d="100"/>
        </p:scale>
        <p:origin x="1420" y="108"/>
      </p:cViewPr>
      <p:guideLst>
        <p:guide orient="horz" pos="2835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472842"/>
            <a:ext cx="5201841" cy="3133172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726842"/>
            <a:ext cx="4589860" cy="217280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1788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620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79142"/>
            <a:ext cx="131958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79142"/>
            <a:ext cx="3882256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7159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7858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243638"/>
            <a:ext cx="5278339" cy="3743557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6022610"/>
            <a:ext cx="5278339" cy="196864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6261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395710"/>
            <a:ext cx="2600921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395710"/>
            <a:ext cx="2600921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5364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144"/>
            <a:ext cx="5278339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206137"/>
            <a:ext cx="2588967" cy="108119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287331"/>
            <a:ext cx="258896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206137"/>
            <a:ext cx="2601718" cy="108119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287331"/>
            <a:ext cx="260171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1452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6123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449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99969"/>
            <a:ext cx="1973799" cy="2099892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295769"/>
            <a:ext cx="3098155" cy="6395505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699862"/>
            <a:ext cx="1973799" cy="5001827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8540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99969"/>
            <a:ext cx="1973799" cy="2099892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295769"/>
            <a:ext cx="3098155" cy="6395505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699862"/>
            <a:ext cx="1973799" cy="5001827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773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79144"/>
            <a:ext cx="5278339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395710"/>
            <a:ext cx="5278339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8341240"/>
            <a:ext cx="137695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121E8-15F7-4CD2-AC99-853457157C7C}" type="datetimeFigureOut">
              <a:rPr lang="zh-CN" altLang="en-US" smtClean="0"/>
              <a:t>2024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8341240"/>
            <a:ext cx="206543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8341240"/>
            <a:ext cx="137695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C5EDB-3B52-4852-AAFF-09543BD39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0319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组合 43">
            <a:extLst>
              <a:ext uri="{FF2B5EF4-FFF2-40B4-BE49-F238E27FC236}">
                <a16:creationId xmlns:a16="http://schemas.microsoft.com/office/drawing/2014/main" id="{BC7877DB-BFFA-B5DA-CE19-2DC35403E907}"/>
              </a:ext>
            </a:extLst>
          </p:cNvPr>
          <p:cNvGrpSpPr/>
          <p:nvPr/>
        </p:nvGrpSpPr>
        <p:grpSpPr>
          <a:xfrm>
            <a:off x="3059906" y="331707"/>
            <a:ext cx="1357745" cy="2137253"/>
            <a:chOff x="3729407" y="4013675"/>
            <a:chExt cx="1357745" cy="2137253"/>
          </a:xfrm>
        </p:grpSpPr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8F5830C5-E462-A6BA-E5FD-EE21D6276F31}"/>
                </a:ext>
              </a:extLst>
            </p:cNvPr>
            <p:cNvGrpSpPr/>
            <p:nvPr/>
          </p:nvGrpSpPr>
          <p:grpSpPr>
            <a:xfrm>
              <a:off x="3729407" y="4013675"/>
              <a:ext cx="1150079" cy="2137253"/>
              <a:chOff x="4756398" y="556837"/>
              <a:chExt cx="1447465" cy="2689902"/>
            </a:xfrm>
          </p:grpSpPr>
          <p:grpSp>
            <p:nvGrpSpPr>
              <p:cNvPr id="47" name="组合 46">
                <a:extLst>
                  <a:ext uri="{FF2B5EF4-FFF2-40B4-BE49-F238E27FC236}">
                    <a16:creationId xmlns:a16="http://schemas.microsoft.com/office/drawing/2014/main" id="{CF5F0E9B-60BC-F548-2139-A73F2C3844AD}"/>
                  </a:ext>
                </a:extLst>
              </p:cNvPr>
              <p:cNvGrpSpPr/>
              <p:nvPr/>
            </p:nvGrpSpPr>
            <p:grpSpPr>
              <a:xfrm>
                <a:off x="4756398" y="556837"/>
                <a:ext cx="1447465" cy="2689902"/>
                <a:chOff x="177172" y="44296"/>
                <a:chExt cx="1447465" cy="2689902"/>
              </a:xfrm>
            </p:grpSpPr>
            <p:grpSp>
              <p:nvGrpSpPr>
                <p:cNvPr id="49" name="组合 48">
                  <a:extLst>
                    <a:ext uri="{FF2B5EF4-FFF2-40B4-BE49-F238E27FC236}">
                      <a16:creationId xmlns:a16="http://schemas.microsoft.com/office/drawing/2014/main" id="{BCCCC186-7C21-DE14-B9A6-D47AC24748B7}"/>
                    </a:ext>
                  </a:extLst>
                </p:cNvPr>
                <p:cNvGrpSpPr/>
                <p:nvPr/>
              </p:nvGrpSpPr>
              <p:grpSpPr>
                <a:xfrm>
                  <a:off x="177172" y="511194"/>
                  <a:ext cx="1447465" cy="2223004"/>
                  <a:chOff x="577562" y="909892"/>
                  <a:chExt cx="1447465" cy="2223004"/>
                </a:xfrm>
              </p:grpSpPr>
              <p:sp>
                <p:nvSpPr>
                  <p:cNvPr id="51" name="文本框 50">
                    <a:extLst>
                      <a:ext uri="{FF2B5EF4-FFF2-40B4-BE49-F238E27FC236}">
                        <a16:creationId xmlns:a16="http://schemas.microsoft.com/office/drawing/2014/main" id="{AEC816B2-CE7F-0BAA-E92A-6A521E9C36F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0227" y="1317227"/>
                    <a:ext cx="1085823" cy="271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thione[%]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文本框 51">
                    <a:extLst>
                      <a:ext uri="{FF2B5EF4-FFF2-40B4-BE49-F238E27FC236}">
                        <a16:creationId xmlns:a16="http://schemas.microsoft.com/office/drawing/2014/main" id="{4016AD9A-7893-3496-D3CA-8066F4C5391C}"/>
                      </a:ext>
                    </a:extLst>
                  </p:cNvPr>
                  <p:cNvSpPr txBox="1"/>
                  <p:nvPr/>
                </p:nvSpPr>
                <p:spPr>
                  <a:xfrm rot="18281348">
                    <a:off x="1173981" y="2353790"/>
                    <a:ext cx="418027" cy="271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C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文本框 52">
                    <a:extLst>
                      <a:ext uri="{FF2B5EF4-FFF2-40B4-BE49-F238E27FC236}">
                        <a16:creationId xmlns:a16="http://schemas.microsoft.com/office/drawing/2014/main" id="{DDBFBDE9-FF71-B818-49F2-416198FA6210}"/>
                      </a:ext>
                    </a:extLst>
                  </p:cNvPr>
                  <p:cNvSpPr txBox="1"/>
                  <p:nvPr/>
                </p:nvSpPr>
                <p:spPr>
                  <a:xfrm rot="18281348">
                    <a:off x="1164545" y="2553762"/>
                    <a:ext cx="799336" cy="271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EGFR-1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" name="文本框 53">
                    <a:extLst>
                      <a:ext uri="{FF2B5EF4-FFF2-40B4-BE49-F238E27FC236}">
                        <a16:creationId xmlns:a16="http://schemas.microsoft.com/office/drawing/2014/main" id="{FD3C1BDF-1784-579C-E80C-EA04E4E2D1A8}"/>
                      </a:ext>
                    </a:extLst>
                  </p:cNvPr>
                  <p:cNvSpPr txBox="1"/>
                  <p:nvPr/>
                </p:nvSpPr>
                <p:spPr>
                  <a:xfrm rot="18281348">
                    <a:off x="1489783" y="2597651"/>
                    <a:ext cx="799336" cy="271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EGFR-2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865E759E-F829-1B26-FBD1-B7FF4B7D4AA3}"/>
                    </a:ext>
                  </a:extLst>
                </p:cNvPr>
                <p:cNvSpPr txBox="1"/>
                <p:nvPr/>
              </p:nvSpPr>
              <p:spPr>
                <a:xfrm>
                  <a:off x="1004254" y="44296"/>
                  <a:ext cx="579427" cy="2711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-10B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10D51B30-33E0-23A0-C3E3-493AEBF1691B}"/>
                  </a:ext>
                </a:extLst>
              </p:cNvPr>
              <p:cNvSpPr txBox="1"/>
              <p:nvPr/>
            </p:nvSpPr>
            <p:spPr>
              <a:xfrm>
                <a:off x="5058532" y="562446"/>
                <a:ext cx="450307" cy="19613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50</a:t>
                </a:r>
              </a:p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662EF6BE-B573-13CD-0630-D6A64CA64F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87224" y="4294260"/>
              <a:ext cx="799928" cy="1212012"/>
            </a:xfrm>
            <a:prstGeom prst="rect">
              <a:avLst/>
            </a:prstGeom>
          </p:spPr>
        </p:pic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31326483-617C-6A23-948C-F457AE9AB975}"/>
              </a:ext>
            </a:extLst>
          </p:cNvPr>
          <p:cNvGrpSpPr/>
          <p:nvPr/>
        </p:nvGrpSpPr>
        <p:grpSpPr>
          <a:xfrm>
            <a:off x="4480631" y="331637"/>
            <a:ext cx="1327160" cy="2073197"/>
            <a:chOff x="5518472" y="3991819"/>
            <a:chExt cx="1327160" cy="2073197"/>
          </a:xfrm>
        </p:grpSpPr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80805AF0-722F-E09E-7790-EB2403747243}"/>
                </a:ext>
              </a:extLst>
            </p:cNvPr>
            <p:cNvGrpSpPr/>
            <p:nvPr/>
          </p:nvGrpSpPr>
          <p:grpSpPr>
            <a:xfrm>
              <a:off x="5518472" y="3991819"/>
              <a:ext cx="1302364" cy="2073197"/>
              <a:chOff x="4756398" y="585105"/>
              <a:chExt cx="1639129" cy="2609283"/>
            </a:xfrm>
          </p:grpSpPr>
          <p:grpSp>
            <p:nvGrpSpPr>
              <p:cNvPr id="58" name="组合 57">
                <a:extLst>
                  <a:ext uri="{FF2B5EF4-FFF2-40B4-BE49-F238E27FC236}">
                    <a16:creationId xmlns:a16="http://schemas.microsoft.com/office/drawing/2014/main" id="{C0B991DE-B781-2307-ED33-B149F048BF3C}"/>
                  </a:ext>
                </a:extLst>
              </p:cNvPr>
              <p:cNvGrpSpPr/>
              <p:nvPr/>
            </p:nvGrpSpPr>
            <p:grpSpPr>
              <a:xfrm>
                <a:off x="4756398" y="598347"/>
                <a:ext cx="1639129" cy="2596041"/>
                <a:chOff x="177172" y="85806"/>
                <a:chExt cx="1639129" cy="2596041"/>
              </a:xfrm>
            </p:grpSpPr>
            <p:grpSp>
              <p:nvGrpSpPr>
                <p:cNvPr id="60" name="组合 59">
                  <a:extLst>
                    <a:ext uri="{FF2B5EF4-FFF2-40B4-BE49-F238E27FC236}">
                      <a16:creationId xmlns:a16="http://schemas.microsoft.com/office/drawing/2014/main" id="{18E53D8A-CE95-2AFF-9ED9-BF8B86BF2F65}"/>
                    </a:ext>
                  </a:extLst>
                </p:cNvPr>
                <p:cNvGrpSpPr/>
                <p:nvPr/>
              </p:nvGrpSpPr>
              <p:grpSpPr>
                <a:xfrm>
                  <a:off x="177172" y="511194"/>
                  <a:ext cx="1639129" cy="2170653"/>
                  <a:chOff x="577562" y="909892"/>
                  <a:chExt cx="1639129" cy="2170653"/>
                </a:xfrm>
              </p:grpSpPr>
              <p:sp>
                <p:nvSpPr>
                  <p:cNvPr id="62" name="文本框 61">
                    <a:extLst>
                      <a:ext uri="{FF2B5EF4-FFF2-40B4-BE49-F238E27FC236}">
                        <a16:creationId xmlns:a16="http://schemas.microsoft.com/office/drawing/2014/main" id="{D95E933A-3482-6BE9-6FA0-B02A9BE52E2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0227" y="1317227"/>
                    <a:ext cx="1085823" cy="271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thione[%]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文本框 62">
                    <a:extLst>
                      <a:ext uri="{FF2B5EF4-FFF2-40B4-BE49-F238E27FC236}">
                        <a16:creationId xmlns:a16="http://schemas.microsoft.com/office/drawing/2014/main" id="{33269A4D-CCB1-8AFF-224E-EFD480EAAC19}"/>
                      </a:ext>
                    </a:extLst>
                  </p:cNvPr>
                  <p:cNvSpPr txBox="1"/>
                  <p:nvPr/>
                </p:nvSpPr>
                <p:spPr>
                  <a:xfrm rot="18281348">
                    <a:off x="1063395" y="2457655"/>
                    <a:ext cx="432151" cy="271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" name="文本框 63">
                    <a:extLst>
                      <a:ext uri="{FF2B5EF4-FFF2-40B4-BE49-F238E27FC236}">
                        <a16:creationId xmlns:a16="http://schemas.microsoft.com/office/drawing/2014/main" id="{E3E7267F-806D-0A58-6209-C603D770DC27}"/>
                      </a:ext>
                    </a:extLst>
                  </p:cNvPr>
                  <p:cNvSpPr txBox="1"/>
                  <p:nvPr/>
                </p:nvSpPr>
                <p:spPr>
                  <a:xfrm rot="18281348">
                    <a:off x="1244534" y="2495064"/>
                    <a:ext cx="744864" cy="42609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efitinib </a:t>
                    </a:r>
                  </a:p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μM)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" name="文本框 64">
                    <a:extLst>
                      <a:ext uri="{FF2B5EF4-FFF2-40B4-BE49-F238E27FC236}">
                        <a16:creationId xmlns:a16="http://schemas.microsoft.com/office/drawing/2014/main" id="{083287C5-3F8D-68B6-87CA-E4D16E9F262E}"/>
                      </a:ext>
                    </a:extLst>
                  </p:cNvPr>
                  <p:cNvSpPr txBox="1"/>
                  <p:nvPr/>
                </p:nvSpPr>
                <p:spPr>
                  <a:xfrm rot="18281348">
                    <a:off x="1631211" y="2495063"/>
                    <a:ext cx="744864" cy="42609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efitinib </a:t>
                    </a:r>
                  </a:p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2μM)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1" name="文本框 60">
                  <a:extLst>
                    <a:ext uri="{FF2B5EF4-FFF2-40B4-BE49-F238E27FC236}">
                      <a16:creationId xmlns:a16="http://schemas.microsoft.com/office/drawing/2014/main" id="{E450443B-A09A-6CEA-DBF6-C87E50507B9A}"/>
                    </a:ext>
                  </a:extLst>
                </p:cNvPr>
                <p:cNvSpPr txBox="1"/>
                <p:nvPr/>
              </p:nvSpPr>
              <p:spPr>
                <a:xfrm>
                  <a:off x="1021665" y="85806"/>
                  <a:ext cx="579427" cy="2711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-10B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4D77589D-A50B-256A-8D0A-7E313F468D43}"/>
                  </a:ext>
                </a:extLst>
              </p:cNvPr>
              <p:cNvSpPr txBox="1"/>
              <p:nvPr/>
            </p:nvSpPr>
            <p:spPr>
              <a:xfrm>
                <a:off x="5033980" y="585105"/>
                <a:ext cx="450307" cy="19613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50</a:t>
                </a:r>
              </a:p>
              <a:p>
                <a:pPr>
                  <a:lnSpc>
                    <a:spcPts val="3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97750241-EF5B-EA54-8CA4-32DBE0A95A1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917" y="4267220"/>
              <a:ext cx="806715" cy="1209103"/>
            </a:xfrm>
            <a:prstGeom prst="rect">
              <a:avLst/>
            </a:prstGeom>
          </p:spPr>
        </p:pic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E80DFFBE-6BA3-46F8-BB05-1229430E52A3}"/>
              </a:ext>
            </a:extLst>
          </p:cNvPr>
          <p:cNvGrpSpPr/>
          <p:nvPr/>
        </p:nvGrpSpPr>
        <p:grpSpPr>
          <a:xfrm>
            <a:off x="3283258" y="3140853"/>
            <a:ext cx="2560874" cy="1845330"/>
            <a:chOff x="2608947" y="2278425"/>
            <a:chExt cx="2560874" cy="1845330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AF3DD579-B8C6-8F70-3EF2-EFF9FD84522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33" t="14280" r="18118" b="16485"/>
            <a:stretch/>
          </p:blipFill>
          <p:spPr>
            <a:xfrm>
              <a:off x="3111014" y="2713970"/>
              <a:ext cx="1512000" cy="1099531"/>
            </a:xfrm>
            <a:prstGeom prst="rect">
              <a:avLst/>
            </a:prstGeom>
          </p:spPr>
        </p:pic>
        <p:grpSp>
          <p:nvGrpSpPr>
            <p:cNvPr id="68" name="组合 67">
              <a:extLst>
                <a:ext uri="{FF2B5EF4-FFF2-40B4-BE49-F238E27FC236}">
                  <a16:creationId xmlns:a16="http://schemas.microsoft.com/office/drawing/2014/main" id="{7F23606E-8EB7-EFEB-7858-DD23BE3B75F7}"/>
                </a:ext>
              </a:extLst>
            </p:cNvPr>
            <p:cNvGrpSpPr/>
            <p:nvPr/>
          </p:nvGrpSpPr>
          <p:grpSpPr>
            <a:xfrm>
              <a:off x="2608947" y="2278425"/>
              <a:ext cx="2560874" cy="1845330"/>
              <a:chOff x="3369851" y="8856183"/>
              <a:chExt cx="2560874" cy="1845330"/>
            </a:xfrm>
          </p:grpSpPr>
          <p:grpSp>
            <p:nvGrpSpPr>
              <p:cNvPr id="69" name="组合 68">
                <a:extLst>
                  <a:ext uri="{FF2B5EF4-FFF2-40B4-BE49-F238E27FC236}">
                    <a16:creationId xmlns:a16="http://schemas.microsoft.com/office/drawing/2014/main" id="{A7C9E100-AD30-4B24-1AC4-C89311586E2F}"/>
                  </a:ext>
                </a:extLst>
              </p:cNvPr>
              <p:cNvGrpSpPr/>
              <p:nvPr/>
            </p:nvGrpSpPr>
            <p:grpSpPr>
              <a:xfrm>
                <a:off x="3369851" y="9170930"/>
                <a:ext cx="2560874" cy="1530583"/>
                <a:chOff x="3369851" y="9170930"/>
                <a:chExt cx="2560874" cy="1530583"/>
              </a:xfrm>
            </p:grpSpPr>
            <p:sp>
              <p:nvSpPr>
                <p:cNvPr id="72" name="文本框 71">
                  <a:extLst>
                    <a:ext uri="{FF2B5EF4-FFF2-40B4-BE49-F238E27FC236}">
                      <a16:creationId xmlns:a16="http://schemas.microsoft.com/office/drawing/2014/main" id="{0983D02A-8F32-2019-047C-82D763409B2B}"/>
                    </a:ext>
                  </a:extLst>
                </p:cNvPr>
                <p:cNvSpPr txBox="1"/>
                <p:nvPr/>
              </p:nvSpPr>
              <p:spPr>
                <a:xfrm rot="16200000">
                  <a:off x="2816013" y="9724768"/>
                  <a:ext cx="144623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ly SLC7A11 protein</a:t>
                  </a:r>
                </a:p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文本框 72">
                  <a:extLst>
                    <a:ext uri="{FF2B5EF4-FFF2-40B4-BE49-F238E27FC236}">
                      <a16:creationId xmlns:a16="http://schemas.microsoft.com/office/drawing/2014/main" id="{C90C84AD-A0FD-4994-AC67-97BA44A3E3CD}"/>
                    </a:ext>
                  </a:extLst>
                </p:cNvPr>
                <p:cNvSpPr txBox="1"/>
                <p:nvPr/>
              </p:nvSpPr>
              <p:spPr>
                <a:xfrm>
                  <a:off x="3628130" y="9171005"/>
                  <a:ext cx="328936" cy="12698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ct val="25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  <a:p>
                  <a:pPr>
                    <a:lnSpc>
                      <a:spcPct val="25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  <a:p>
                  <a:pPr>
                    <a:lnSpc>
                      <a:spcPct val="25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  <a:p>
                  <a:pPr>
                    <a:lnSpc>
                      <a:spcPct val="250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CB31A167-F1A2-FD2B-7809-BE92CCBB61C0}"/>
                    </a:ext>
                  </a:extLst>
                </p:cNvPr>
                <p:cNvSpPr txBox="1"/>
                <p:nvPr/>
              </p:nvSpPr>
              <p:spPr>
                <a:xfrm>
                  <a:off x="3830104" y="10362959"/>
                  <a:ext cx="17996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20        40         60        80</a:t>
                  </a:r>
                </a:p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ime (hours)</a:t>
                  </a:r>
                </a:p>
              </p:txBody>
            </p:sp>
            <p:sp>
              <p:nvSpPr>
                <p:cNvPr id="75" name="文本框 74">
                  <a:extLst>
                    <a:ext uri="{FF2B5EF4-FFF2-40B4-BE49-F238E27FC236}">
                      <a16:creationId xmlns:a16="http://schemas.microsoft.com/office/drawing/2014/main" id="{E2EFC54E-45A6-D001-9389-1FEC703416CF}"/>
                    </a:ext>
                  </a:extLst>
                </p:cNvPr>
                <p:cNvSpPr txBox="1"/>
                <p:nvPr/>
              </p:nvSpPr>
              <p:spPr>
                <a:xfrm>
                  <a:off x="5386986" y="9332916"/>
                  <a:ext cx="54373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  <a:p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EGFR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8563CE61-DC3A-7CA4-563E-03E4C2CF7D46}"/>
                  </a:ext>
                </a:extLst>
              </p:cNvPr>
              <p:cNvSpPr txBox="1"/>
              <p:nvPr/>
            </p:nvSpPr>
            <p:spPr>
              <a:xfrm>
                <a:off x="4468201" y="8856183"/>
                <a:ext cx="460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-10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4" name="文本框 103">
            <a:extLst>
              <a:ext uri="{FF2B5EF4-FFF2-40B4-BE49-F238E27FC236}">
                <a16:creationId xmlns:a16="http://schemas.microsoft.com/office/drawing/2014/main" id="{A5059E44-7FFA-6311-A8BB-4093AA89630C}"/>
              </a:ext>
            </a:extLst>
          </p:cNvPr>
          <p:cNvSpPr txBox="1"/>
          <p:nvPr/>
        </p:nvSpPr>
        <p:spPr>
          <a:xfrm>
            <a:off x="164846" y="101369"/>
            <a:ext cx="465750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B</a:t>
            </a: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D5605F7-3490-6C81-F954-C0C986A57415}"/>
              </a:ext>
            </a:extLst>
          </p:cNvPr>
          <p:cNvSpPr txBox="1"/>
          <p:nvPr/>
        </p:nvSpPr>
        <p:spPr>
          <a:xfrm>
            <a:off x="305924" y="6338563"/>
            <a:ext cx="5566527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00" b="1" kern="10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</a:t>
            </a:r>
            <a:r>
              <a:rPr lang="en-US" altLang="zh-CN" sz="10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1. EGFR stabilizes SLC7A11 protein expression in NPC via a kinase-independent mechanism</a:t>
            </a:r>
            <a:endParaRPr lang="zh-CN" altLang="zh-CN" sz="10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Immunoblotting was used to analyze SLC7A11, and both total and phosphorylated EGFR in 6-10B cells. (B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In 6-10B cells, glutathione levels were assessed post-EGFR knockdown (left) or after gefitinib treatment (right). (C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In 6-10B cells transfected with control or EGFR siRNAs for 48h and subsequently exposed to cycloheximide (CHX, 100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μg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/ml), immunoblot analysis was conducted for SLC7A11 (left). The SLC7A11/β-actin band intensity ratios revealed the protein half-life of SLC7A11 (right).</a:t>
            </a:r>
            <a:endParaRPr lang="zh-CN" altLang="zh-CN" sz="10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AA07D012-5FC0-FE2B-346D-40CA2EC56D41}"/>
              </a:ext>
            </a:extLst>
          </p:cNvPr>
          <p:cNvGrpSpPr/>
          <p:nvPr/>
        </p:nvGrpSpPr>
        <p:grpSpPr>
          <a:xfrm>
            <a:off x="297720" y="256317"/>
            <a:ext cx="3472260" cy="1979060"/>
            <a:chOff x="297720" y="256317"/>
            <a:chExt cx="3472260" cy="1979060"/>
          </a:xfrm>
        </p:grpSpPr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7ECB4B38-3AD5-25E5-2601-9BC0A76A1827}"/>
                </a:ext>
              </a:extLst>
            </p:cNvPr>
            <p:cNvGrpSpPr/>
            <p:nvPr/>
          </p:nvGrpSpPr>
          <p:grpSpPr>
            <a:xfrm>
              <a:off x="297720" y="256317"/>
              <a:ext cx="3472260" cy="1979060"/>
              <a:chOff x="297720" y="256317"/>
              <a:chExt cx="3472260" cy="1979060"/>
            </a:xfrm>
          </p:grpSpPr>
          <p:grpSp>
            <p:nvGrpSpPr>
              <p:cNvPr id="102" name="组合 101">
                <a:extLst>
                  <a:ext uri="{FF2B5EF4-FFF2-40B4-BE49-F238E27FC236}">
                    <a16:creationId xmlns:a16="http://schemas.microsoft.com/office/drawing/2014/main" id="{65763C31-CD8D-3F66-9D13-1F7F537C8234}"/>
                  </a:ext>
                </a:extLst>
              </p:cNvPr>
              <p:cNvGrpSpPr/>
              <p:nvPr/>
            </p:nvGrpSpPr>
            <p:grpSpPr>
              <a:xfrm>
                <a:off x="297720" y="256317"/>
                <a:ext cx="3472260" cy="1967257"/>
                <a:chOff x="795297" y="2006230"/>
                <a:chExt cx="3472260" cy="1967257"/>
              </a:xfrm>
            </p:grpSpPr>
            <p:grpSp>
              <p:nvGrpSpPr>
                <p:cNvPr id="78" name="组合 77">
                  <a:extLst>
                    <a:ext uri="{FF2B5EF4-FFF2-40B4-BE49-F238E27FC236}">
                      <a16:creationId xmlns:a16="http://schemas.microsoft.com/office/drawing/2014/main" id="{CE26D267-A8AF-6EF7-4A98-5511A89AD980}"/>
                    </a:ext>
                  </a:extLst>
                </p:cNvPr>
                <p:cNvGrpSpPr/>
                <p:nvPr/>
              </p:nvGrpSpPr>
              <p:grpSpPr>
                <a:xfrm>
                  <a:off x="795297" y="2006230"/>
                  <a:ext cx="3472260" cy="1967257"/>
                  <a:chOff x="1237291" y="1621923"/>
                  <a:chExt cx="7431194" cy="4210249"/>
                </a:xfrm>
              </p:grpSpPr>
              <p:grpSp>
                <p:nvGrpSpPr>
                  <p:cNvPr id="81" name="组合 80">
                    <a:extLst>
                      <a:ext uri="{FF2B5EF4-FFF2-40B4-BE49-F238E27FC236}">
                        <a16:creationId xmlns:a16="http://schemas.microsoft.com/office/drawing/2014/main" id="{49C3619E-A768-115F-6E59-05DCA4075FF3}"/>
                      </a:ext>
                    </a:extLst>
                  </p:cNvPr>
                  <p:cNvGrpSpPr/>
                  <p:nvPr/>
                </p:nvGrpSpPr>
                <p:grpSpPr>
                  <a:xfrm>
                    <a:off x="2531460" y="2415894"/>
                    <a:ext cx="6137025" cy="883157"/>
                    <a:chOff x="2531460" y="2415894"/>
                    <a:chExt cx="6137025" cy="883157"/>
                  </a:xfrm>
                </p:grpSpPr>
                <p:sp>
                  <p:nvSpPr>
                    <p:cNvPr id="96" name="文本框 95">
                      <a:extLst>
                        <a:ext uri="{FF2B5EF4-FFF2-40B4-BE49-F238E27FC236}">
                          <a16:creationId xmlns:a16="http://schemas.microsoft.com/office/drawing/2014/main" id="{A9B3BB58-D294-3659-48FC-2B224C5F8F6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31460" y="2837966"/>
                      <a:ext cx="6017005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     -  1μM 2μM    -  1μM  2μM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7" name="文本框 96">
                      <a:extLst>
                        <a:ext uri="{FF2B5EF4-FFF2-40B4-BE49-F238E27FC236}">
                          <a16:creationId xmlns:a16="http://schemas.microsoft.com/office/drawing/2014/main" id="{95FBB8A1-61D1-0C2C-805C-6BF516ECCA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51480" y="2415894"/>
                      <a:ext cx="6017005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     +    +      +      +     +      +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82" name="组合 81">
                    <a:extLst>
                      <a:ext uri="{FF2B5EF4-FFF2-40B4-BE49-F238E27FC236}">
                        <a16:creationId xmlns:a16="http://schemas.microsoft.com/office/drawing/2014/main" id="{B6D2B3CA-FD32-0B41-A75C-0DEA35B29D10}"/>
                      </a:ext>
                    </a:extLst>
                  </p:cNvPr>
                  <p:cNvGrpSpPr/>
                  <p:nvPr/>
                </p:nvGrpSpPr>
                <p:grpSpPr>
                  <a:xfrm>
                    <a:off x="1237291" y="1621923"/>
                    <a:ext cx="4695640" cy="4210249"/>
                    <a:chOff x="1237291" y="1621923"/>
                    <a:chExt cx="4695640" cy="4210249"/>
                  </a:xfrm>
                </p:grpSpPr>
                <p:sp>
                  <p:nvSpPr>
                    <p:cNvPr id="83" name="文本框 82">
                      <a:extLst>
                        <a:ext uri="{FF2B5EF4-FFF2-40B4-BE49-F238E27FC236}">
                          <a16:creationId xmlns:a16="http://schemas.microsoft.com/office/drawing/2014/main" id="{BA86DCBD-4D50-8EFC-4D0B-C920FDDE185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37291" y="3922698"/>
                      <a:ext cx="1005875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4" name="文本框 83">
                      <a:extLst>
                        <a:ext uri="{FF2B5EF4-FFF2-40B4-BE49-F238E27FC236}">
                          <a16:creationId xmlns:a16="http://schemas.microsoft.com/office/drawing/2014/main" id="{112DEC52-AD41-3231-FEBA-AE909E89B97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48343" y="3266484"/>
                      <a:ext cx="1342084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7A11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5" name="文本框 84">
                      <a:extLst>
                        <a:ext uri="{FF2B5EF4-FFF2-40B4-BE49-F238E27FC236}">
                          <a16:creationId xmlns:a16="http://schemas.microsoft.com/office/drawing/2014/main" id="{701B46ED-A16F-53A3-125F-6F455A12FC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54849" y="5371087"/>
                      <a:ext cx="1060768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6" name="文本框 85">
                      <a:extLst>
                        <a:ext uri="{FF2B5EF4-FFF2-40B4-BE49-F238E27FC236}">
                          <a16:creationId xmlns:a16="http://schemas.microsoft.com/office/drawing/2014/main" id="{95962558-7066-C7D0-4CDD-07172B3972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37013" y="1621923"/>
                      <a:ext cx="985291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10B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7" name="文本框 86">
                      <a:extLst>
                        <a:ext uri="{FF2B5EF4-FFF2-40B4-BE49-F238E27FC236}">
                          <a16:creationId xmlns:a16="http://schemas.microsoft.com/office/drawing/2014/main" id="{CA68275C-D807-48B0-A8B7-83686C0DAA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45907" y="4693786"/>
                      <a:ext cx="1201426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EGFR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8" name="文本框 87">
                      <a:extLst>
                        <a:ext uri="{FF2B5EF4-FFF2-40B4-BE49-F238E27FC236}">
                          <a16:creationId xmlns:a16="http://schemas.microsoft.com/office/drawing/2014/main" id="{AC143F69-56B8-BF53-676D-129F4AEC31D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48343" y="2857191"/>
                      <a:ext cx="1204857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fitinib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9" name="文本框 88">
                      <a:extLst>
                        <a:ext uri="{FF2B5EF4-FFF2-40B4-BE49-F238E27FC236}">
                          <a16:creationId xmlns:a16="http://schemas.microsoft.com/office/drawing/2014/main" id="{F3E8EC82-05AF-1E9A-65F8-C0431CA69B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70068" y="2421244"/>
                      <a:ext cx="848064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90" name="直接连接符 89">
                      <a:extLst>
                        <a:ext uri="{FF2B5EF4-FFF2-40B4-BE49-F238E27FC236}">
                          <a16:creationId xmlns:a16="http://schemas.microsoft.com/office/drawing/2014/main" id="{5AE884FA-2BF9-F0E2-6D62-70E93A90856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268376" y="2405817"/>
                      <a:ext cx="1232732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" name="直接连接符 90">
                      <a:extLst>
                        <a:ext uri="{FF2B5EF4-FFF2-40B4-BE49-F238E27FC236}">
                          <a16:creationId xmlns:a16="http://schemas.microsoft.com/office/drawing/2014/main" id="{CD2A2CA9-73F6-E80A-12FB-F4EAF13EFA3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700199" y="2404276"/>
                      <a:ext cx="1232732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2" name="文本框 91">
                      <a:extLst>
                        <a:ext uri="{FF2B5EF4-FFF2-40B4-BE49-F238E27FC236}">
                          <a16:creationId xmlns:a16="http://schemas.microsoft.com/office/drawing/2014/main" id="{13CB7061-4C9B-AD57-9248-FF83D0B9B2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54171" y="2019972"/>
                      <a:ext cx="765728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3" name="文本框 92">
                      <a:extLst>
                        <a:ext uri="{FF2B5EF4-FFF2-40B4-BE49-F238E27FC236}">
                          <a16:creationId xmlns:a16="http://schemas.microsoft.com/office/drawing/2014/main" id="{EADFB424-F732-0E47-203B-578822CEFE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16895" y="2020342"/>
                      <a:ext cx="765728" cy="461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h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pic>
              <p:nvPicPr>
                <p:cNvPr id="98" name="图片 97">
                  <a:extLst>
                    <a:ext uri="{FF2B5EF4-FFF2-40B4-BE49-F238E27FC236}">
                      <a16:creationId xmlns:a16="http://schemas.microsoft.com/office/drawing/2014/main" id="{25B5B577-2237-C43F-7BAE-EA3EEDADDEF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450460" y="2817304"/>
                  <a:ext cx="1512000" cy="216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99" name="图片 98">
                  <a:extLst>
                    <a:ext uri="{FF2B5EF4-FFF2-40B4-BE49-F238E27FC236}">
                      <a16:creationId xmlns:a16="http://schemas.microsoft.com/office/drawing/2014/main" id="{264B59C1-7735-3E96-BF51-357E5A0B431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449550" y="3124377"/>
                  <a:ext cx="1512000" cy="216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00" name="图片 99">
                  <a:extLst>
                    <a:ext uri="{FF2B5EF4-FFF2-40B4-BE49-F238E27FC236}">
                      <a16:creationId xmlns:a16="http://schemas.microsoft.com/office/drawing/2014/main" id="{784EC13A-13EA-22D5-CACF-B8BC09D027E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1447598" y="3426480"/>
                  <a:ext cx="1512000" cy="216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01" name="图片 100">
                  <a:extLst>
                    <a:ext uri="{FF2B5EF4-FFF2-40B4-BE49-F238E27FC236}">
                      <a16:creationId xmlns:a16="http://schemas.microsoft.com/office/drawing/2014/main" id="{FF2D2A67-FB09-E555-AC7E-B07BA901F9C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1442118" y="3723613"/>
                  <a:ext cx="1512000" cy="216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</p:grp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59BF9512-8AB5-0509-0C4D-7C5724F98F1E}"/>
                  </a:ext>
                </a:extLst>
              </p:cNvPr>
              <p:cNvSpPr txBox="1"/>
              <p:nvPr/>
            </p:nvSpPr>
            <p:spPr>
              <a:xfrm>
                <a:off x="2513233" y="1362609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3BB15DCC-B242-DF94-D248-2FA6B2FE7374}"/>
                  </a:ext>
                </a:extLst>
              </p:cNvPr>
              <p:cNvSpPr txBox="1"/>
              <p:nvPr/>
            </p:nvSpPr>
            <p:spPr>
              <a:xfrm>
                <a:off x="2521423" y="171969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65DDBBD5-7CE7-2350-BA0C-620F953D6F41}"/>
                  </a:ext>
                </a:extLst>
              </p:cNvPr>
              <p:cNvSpPr txBox="1"/>
              <p:nvPr/>
            </p:nvSpPr>
            <p:spPr>
              <a:xfrm>
                <a:off x="2422135" y="1076593"/>
                <a:ext cx="574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-55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BBABB0DB-1FDC-0868-B8C9-54ED8F4838DF}"/>
                  </a:ext>
                </a:extLst>
              </p:cNvPr>
              <p:cNvSpPr txBox="1"/>
              <p:nvPr/>
            </p:nvSpPr>
            <p:spPr>
              <a:xfrm>
                <a:off x="2567617" y="2019933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83F801E-BAB5-968E-EB44-1C64260195C4}"/>
                </a:ext>
              </a:extLst>
            </p:cNvPr>
            <p:cNvSpPr txBox="1"/>
            <p:nvPr/>
          </p:nvSpPr>
          <p:spPr>
            <a:xfrm>
              <a:off x="903136" y="1234158"/>
              <a:ext cx="16398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1.03   1.03    1.01  1.00    1.00   1.11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9C7821E-28E1-0D88-B4B5-6D9C6274F822}"/>
                </a:ext>
              </a:extLst>
            </p:cNvPr>
            <p:cNvSpPr txBox="1"/>
            <p:nvPr/>
          </p:nvSpPr>
          <p:spPr>
            <a:xfrm>
              <a:off x="911412" y="1540622"/>
              <a:ext cx="16398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57   0.82   0.72   0.58   0.80   0.92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BC96293-34D1-2C7B-8E32-F9B5C52F9D64}"/>
                </a:ext>
              </a:extLst>
            </p:cNvPr>
            <p:cNvSpPr txBox="1"/>
            <p:nvPr/>
          </p:nvSpPr>
          <p:spPr>
            <a:xfrm>
              <a:off x="914719" y="1837151"/>
              <a:ext cx="16398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zh-CN" sz="600">
                  <a:latin typeface="Arial" panose="020B0604020202020204" pitchFamily="34" charset="0"/>
                  <a:cs typeface="Arial" panose="020B0604020202020204" pitchFamily="34" charset="0"/>
                </a:rPr>
                <a:t>1     2.42   1.05   1.03    2.49   1.07   0.58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957B596F-943A-E46F-1634-32B08DD6485A}"/>
              </a:ext>
            </a:extLst>
          </p:cNvPr>
          <p:cNvGrpSpPr/>
          <p:nvPr/>
        </p:nvGrpSpPr>
        <p:grpSpPr>
          <a:xfrm>
            <a:off x="255443" y="3037505"/>
            <a:ext cx="3362280" cy="1978920"/>
            <a:chOff x="255443" y="3037505"/>
            <a:chExt cx="3362280" cy="1978920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5CBC5D8E-16FC-8561-A51B-434067E9BBC5}"/>
                </a:ext>
              </a:extLst>
            </p:cNvPr>
            <p:cNvGrpSpPr/>
            <p:nvPr/>
          </p:nvGrpSpPr>
          <p:grpSpPr>
            <a:xfrm>
              <a:off x="255443" y="3037505"/>
              <a:ext cx="3362280" cy="1978920"/>
              <a:chOff x="255443" y="3037505"/>
              <a:chExt cx="3362280" cy="1978920"/>
            </a:xfrm>
          </p:grpSpPr>
          <p:grpSp>
            <p:nvGrpSpPr>
              <p:cNvPr id="103" name="组合 102">
                <a:extLst>
                  <a:ext uri="{FF2B5EF4-FFF2-40B4-BE49-F238E27FC236}">
                    <a16:creationId xmlns:a16="http://schemas.microsoft.com/office/drawing/2014/main" id="{A9A8B149-7588-0A4F-2740-48F28BDCCBD3}"/>
                  </a:ext>
                </a:extLst>
              </p:cNvPr>
              <p:cNvGrpSpPr/>
              <p:nvPr/>
            </p:nvGrpSpPr>
            <p:grpSpPr>
              <a:xfrm>
                <a:off x="255443" y="3037505"/>
                <a:ext cx="3362280" cy="1968979"/>
                <a:chOff x="208195" y="428990"/>
                <a:chExt cx="3362280" cy="1968979"/>
              </a:xfrm>
            </p:grpSpPr>
            <p:grpSp>
              <p:nvGrpSpPr>
                <p:cNvPr id="4" name="组合 3">
                  <a:extLst>
                    <a:ext uri="{FF2B5EF4-FFF2-40B4-BE49-F238E27FC236}">
                      <a16:creationId xmlns:a16="http://schemas.microsoft.com/office/drawing/2014/main" id="{152F1BF2-0D30-04AF-3859-C65C2B760CD7}"/>
                    </a:ext>
                  </a:extLst>
                </p:cNvPr>
                <p:cNvGrpSpPr/>
                <p:nvPr/>
              </p:nvGrpSpPr>
              <p:grpSpPr>
                <a:xfrm>
                  <a:off x="208195" y="428990"/>
                  <a:ext cx="3236372" cy="1968979"/>
                  <a:chOff x="44865" y="971884"/>
                  <a:chExt cx="3815040" cy="2321035"/>
                </a:xfrm>
              </p:grpSpPr>
              <p:grpSp>
                <p:nvGrpSpPr>
                  <p:cNvPr id="11" name="组合 10">
                    <a:extLst>
                      <a:ext uri="{FF2B5EF4-FFF2-40B4-BE49-F238E27FC236}">
                        <a16:creationId xmlns:a16="http://schemas.microsoft.com/office/drawing/2014/main" id="{B3586E46-F715-C017-EBB1-43CCEC49D78E}"/>
                      </a:ext>
                    </a:extLst>
                  </p:cNvPr>
                  <p:cNvGrpSpPr/>
                  <p:nvPr/>
                </p:nvGrpSpPr>
                <p:grpSpPr>
                  <a:xfrm>
                    <a:off x="44865" y="971884"/>
                    <a:ext cx="3815040" cy="2303340"/>
                    <a:chOff x="1552188" y="1229486"/>
                    <a:chExt cx="7100839" cy="4287149"/>
                  </a:xfrm>
                </p:grpSpPr>
                <p:sp>
                  <p:nvSpPr>
                    <p:cNvPr id="14" name="文本框 13">
                      <a:extLst>
                        <a:ext uri="{FF2B5EF4-FFF2-40B4-BE49-F238E27FC236}">
                          <a16:creationId xmlns:a16="http://schemas.microsoft.com/office/drawing/2014/main" id="{83557AF5-ECD7-7E2E-D77F-C25C887F83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51478" y="2888887"/>
                      <a:ext cx="6001549" cy="472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5" name="组合 14">
                      <a:extLst>
                        <a:ext uri="{FF2B5EF4-FFF2-40B4-BE49-F238E27FC236}">
                          <a16:creationId xmlns:a16="http://schemas.microsoft.com/office/drawing/2014/main" id="{E6DB6B88-2095-7ED6-5E0A-A61B092199A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52188" y="1229486"/>
                      <a:ext cx="3597781" cy="4287149"/>
                      <a:chOff x="1552188" y="1229486"/>
                      <a:chExt cx="3597781" cy="4287149"/>
                    </a:xfrm>
                  </p:grpSpPr>
                  <p:sp>
                    <p:nvSpPr>
                      <p:cNvPr id="16" name="文本框 15">
                        <a:extLst>
                          <a:ext uri="{FF2B5EF4-FFF2-40B4-BE49-F238E27FC236}">
                            <a16:creationId xmlns:a16="http://schemas.microsoft.com/office/drawing/2014/main" id="{4C81B779-9901-E971-F18F-E5A84FF7942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52188" y="4370434"/>
                        <a:ext cx="1375893" cy="472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LC7A11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7" name="文本框 16">
                        <a:extLst>
                          <a:ext uri="{FF2B5EF4-FFF2-40B4-BE49-F238E27FC236}">
                            <a16:creationId xmlns:a16="http://schemas.microsoft.com/office/drawing/2014/main" id="{AE3B4F3F-9510-086D-3B59-2F2A2661AF5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68262" y="3689669"/>
                        <a:ext cx="1031215" cy="472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GFR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8" name="文本框 17">
                        <a:extLst>
                          <a:ext uri="{FF2B5EF4-FFF2-40B4-BE49-F238E27FC236}">
                            <a16:creationId xmlns:a16="http://schemas.microsoft.com/office/drawing/2014/main" id="{94776443-3CF9-84AC-3AE4-E6611A991F1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75741" y="5043935"/>
                        <a:ext cx="1087491" cy="472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β-actin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9" name="文本框 18">
                        <a:extLst>
                          <a:ext uri="{FF2B5EF4-FFF2-40B4-BE49-F238E27FC236}">
                            <a16:creationId xmlns:a16="http://schemas.microsoft.com/office/drawing/2014/main" id="{EE8DBDE3-B439-7516-D2E4-0CBA5015B92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76549" y="1229486"/>
                        <a:ext cx="1073420" cy="472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-10B 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pic>
                <p:nvPicPr>
                  <p:cNvPr id="6" name="图片 5">
                    <a:extLst>
                      <a:ext uri="{FF2B5EF4-FFF2-40B4-BE49-F238E27FC236}">
                        <a16:creationId xmlns:a16="http://schemas.microsoft.com/office/drawing/2014/main" id="{7A1A4BD3-D0F1-06B1-A01D-D9EB9C267022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701637" y="3038298"/>
                    <a:ext cx="2036968" cy="254621"/>
                  </a:xfrm>
                  <a:prstGeom prst="rect">
                    <a:avLst/>
                  </a:prstGeom>
                  <a:ln w="6350" cap="sq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</p:pic>
              <p:pic>
                <p:nvPicPr>
                  <p:cNvPr id="7" name="图片 6">
                    <a:extLst>
                      <a:ext uri="{FF2B5EF4-FFF2-40B4-BE49-F238E27FC236}">
                        <a16:creationId xmlns:a16="http://schemas.microsoft.com/office/drawing/2014/main" id="{A1D764CF-0C0D-2FA8-DB7E-234800794BF4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701643" y="2300791"/>
                    <a:ext cx="2036968" cy="254826"/>
                  </a:xfrm>
                  <a:prstGeom prst="rect">
                    <a:avLst/>
                  </a:prstGeom>
                  <a:ln w="6350" cap="sq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</p:pic>
              <p:pic>
                <p:nvPicPr>
                  <p:cNvPr id="8" name="图片 7">
                    <a:extLst>
                      <a:ext uri="{FF2B5EF4-FFF2-40B4-BE49-F238E27FC236}">
                        <a16:creationId xmlns:a16="http://schemas.microsoft.com/office/drawing/2014/main" id="{7EDCC993-D74E-BEB6-9502-B965A9B4390E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11"/>
                  <a:stretch>
                    <a:fillRect/>
                  </a:stretch>
                </p:blipFill>
                <p:spPr>
                  <a:xfrm>
                    <a:off x="701355" y="2661834"/>
                    <a:ext cx="2036968" cy="254621"/>
                  </a:xfrm>
                  <a:prstGeom prst="rect">
                    <a:avLst/>
                  </a:prstGeom>
                  <a:ln w="6350" cap="sq">
                    <a:solidFill>
                      <a:srgbClr val="000000"/>
                    </a:solidFill>
                    <a:prstDash val="solid"/>
                    <a:miter lim="800000"/>
                  </a:ln>
                  <a:effectLst/>
                </p:spPr>
              </p:pic>
            </p:grpSp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id="{BF5AAFB5-24AF-C9C2-F759-0E73F5C73761}"/>
                    </a:ext>
                  </a:extLst>
                </p:cNvPr>
                <p:cNvSpPr txBox="1"/>
                <p:nvPr/>
              </p:nvSpPr>
              <p:spPr>
                <a:xfrm>
                  <a:off x="218016" y="1129068"/>
                  <a:ext cx="33524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EGFR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-      -      -      -      +     +      +      + </a:t>
                  </a:r>
                </a:p>
              </p:txBody>
            </p:sp>
            <p:sp>
              <p:nvSpPr>
                <p:cNvPr id="3" name="文本框 2">
                  <a:extLst>
                    <a:ext uri="{FF2B5EF4-FFF2-40B4-BE49-F238E27FC236}">
                      <a16:creationId xmlns:a16="http://schemas.microsoft.com/office/drawing/2014/main" id="{A3DE5884-57C0-82EC-1133-BEAA5D8DF24A}"/>
                    </a:ext>
                  </a:extLst>
                </p:cNvPr>
                <p:cNvSpPr txBox="1"/>
                <p:nvPr/>
              </p:nvSpPr>
              <p:spPr>
                <a:xfrm>
                  <a:off x="215389" y="742380"/>
                  <a:ext cx="32659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X             +     +     +     +     +     +      +      + 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2632D922-5F64-F4C7-E509-B5CCAF2DF4E5}"/>
                    </a:ext>
                  </a:extLst>
                </p:cNvPr>
                <p:cNvSpPr txBox="1"/>
                <p:nvPr/>
              </p:nvSpPr>
              <p:spPr>
                <a:xfrm>
                  <a:off x="224631" y="932120"/>
                  <a:ext cx="327340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               +     +     +     +      -      -      -       -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1F3E870A-2097-BB59-875E-5A70A1DEB222}"/>
                    </a:ext>
                  </a:extLst>
                </p:cNvPr>
                <p:cNvSpPr txBox="1"/>
                <p:nvPr/>
              </p:nvSpPr>
              <p:spPr>
                <a:xfrm>
                  <a:off x="214961" y="1322665"/>
                  <a:ext cx="2464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imes (h)     0     24   36  48     0     24    36   48 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169BF584-7AE1-C576-D509-DFEEFFC8D81D}"/>
                  </a:ext>
                </a:extLst>
              </p:cNvPr>
              <p:cNvSpPr txBox="1"/>
              <p:nvPr/>
            </p:nvSpPr>
            <p:spPr>
              <a:xfrm>
                <a:off x="2579764" y="4133266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C1567D6-CE0C-90CD-F864-3AC8066ADA05}"/>
                  </a:ext>
                </a:extLst>
              </p:cNvPr>
              <p:cNvSpPr txBox="1"/>
              <p:nvPr/>
            </p:nvSpPr>
            <p:spPr>
              <a:xfrm>
                <a:off x="2498692" y="4470130"/>
                <a:ext cx="574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-55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4983DF42-835A-909F-B530-45A9D6FE13E9}"/>
                  </a:ext>
                </a:extLst>
              </p:cNvPr>
              <p:cNvSpPr txBox="1"/>
              <p:nvPr/>
            </p:nvSpPr>
            <p:spPr>
              <a:xfrm>
                <a:off x="2650582" y="4800981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0D968FE3-BC89-BEB5-6BC9-CBCE4F1D8868}"/>
                </a:ext>
              </a:extLst>
            </p:cNvPr>
            <p:cNvSpPr txBox="1"/>
            <p:nvPr/>
          </p:nvSpPr>
          <p:spPr>
            <a:xfrm>
              <a:off x="760047" y="4333258"/>
              <a:ext cx="19662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1.13   0.91   0.47   0.64    0.19   0.05   0.03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DE34B044-5F5A-0D08-CF09-E77B804F6744}"/>
                </a:ext>
              </a:extLst>
            </p:cNvPr>
            <p:cNvSpPr txBox="1"/>
            <p:nvPr/>
          </p:nvSpPr>
          <p:spPr>
            <a:xfrm>
              <a:off x="758898" y="4639733"/>
              <a:ext cx="19662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0.83   0.66   0.40       1      0.57   0.36   0.1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51782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4</TotalTime>
  <Words>283</Words>
  <Application>Microsoft Office PowerPoint</Application>
  <PresentationFormat>自定义</PresentationFormat>
  <Paragraphs>8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yuan</dc:creator>
  <cp:lastModifiedBy>weiyuan wang</cp:lastModifiedBy>
  <cp:revision>12</cp:revision>
  <dcterms:created xsi:type="dcterms:W3CDTF">2023-09-13T11:23:23Z</dcterms:created>
  <dcterms:modified xsi:type="dcterms:W3CDTF">2024-10-19T09:30:49Z</dcterms:modified>
</cp:coreProperties>
</file>